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71" r:id="rId10"/>
    <p:sldId id="272" r:id="rId11"/>
    <p:sldId id="273" r:id="rId12"/>
    <p:sldId id="266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7"/>
    <p:restoredTop sz="94844"/>
  </p:normalViewPr>
  <p:slideViewPr>
    <p:cSldViewPr snapToGrid="0" showGuides="1">
      <p:cViewPr varScale="1">
        <p:scale>
          <a:sx n="140" d="100"/>
          <a:sy n="140" d="100"/>
        </p:scale>
        <p:origin x="632" y="17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6/07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44523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5873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84616"/>
            <a:ext cx="6914808" cy="516835"/>
          </a:xfrm>
        </p:spPr>
        <p:txBody>
          <a:bodyPr>
            <a:noAutofit/>
          </a:bodyPr>
          <a:lstStyle/>
          <a:p>
            <a:r>
              <a:rPr lang="en-GB" dirty="0"/>
              <a:t>Technical feasibility of leadless left bundle branch area pacing for cardiac resynchronisation: a case seri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345865"/>
            <a:ext cx="6119812" cy="360363"/>
          </a:xfrm>
        </p:spPr>
        <p:txBody>
          <a:bodyPr/>
          <a:lstStyle/>
          <a:p>
            <a:r>
              <a:rPr lang="en-GB" dirty="0"/>
              <a:t>June 2021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403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92575" y="892629"/>
            <a:ext cx="7710778" cy="3635828"/>
          </a:xfrm>
        </p:spPr>
        <p:txBody>
          <a:bodyPr>
            <a:normAutofit fontScale="77500" lnSpcReduction="20000"/>
          </a:bodyPr>
          <a:lstStyle/>
          <a:p>
            <a:pPr marL="457200" indent="-457200">
              <a:buFont typeface="+mj-lt"/>
              <a:buAutoNum type="arabicPeriod"/>
            </a:pPr>
            <a:r>
              <a:rPr lang="en-GB" b="0" dirty="0"/>
              <a:t>Zhang W, Huang J, Qi Y, et al. Cardiac resynchronization therapy by left bundle branch area pacing in patients with heart failure and left bundle branch block. </a:t>
            </a:r>
            <a:r>
              <a:rPr lang="en-GB" b="0" i="1" dirty="0"/>
              <a:t>Heart Rhythm</a:t>
            </a:r>
            <a:r>
              <a:rPr lang="en-GB" b="0" dirty="0"/>
              <a:t>. 2019;16(12):1783-1790. doi:10.1016/j.hrthm.2019.09.006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/>
              <a:t>Reddy VY, Miller MA, </a:t>
            </a:r>
            <a:r>
              <a:rPr lang="en-GB" b="0" dirty="0" err="1"/>
              <a:t>Neuzil</a:t>
            </a:r>
            <a:r>
              <a:rPr lang="en-GB" b="0" dirty="0"/>
              <a:t> P, </a:t>
            </a:r>
            <a:r>
              <a:rPr lang="en-GB" b="0" dirty="0" err="1"/>
              <a:t>Søgaard</a:t>
            </a:r>
            <a:r>
              <a:rPr lang="en-GB" b="0" dirty="0"/>
              <a:t> P, Butter C, Seifert M, et al. Cardiac Resynchronization Therapy With Wireless Left Ventricular Endocardial Pacing: The SELECT-LV Study. </a:t>
            </a:r>
            <a:r>
              <a:rPr lang="en-GB" b="0" i="1" dirty="0"/>
              <a:t>Journal of the American College of Cardiology</a:t>
            </a:r>
            <a:r>
              <a:rPr lang="en-GB" b="0" dirty="0"/>
              <a:t>. 2017;69(17):2119–29 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/>
              <a:t>Reddy VY, Miller MA, </a:t>
            </a:r>
            <a:r>
              <a:rPr lang="en-GB" b="0" dirty="0" err="1"/>
              <a:t>Neuzil</a:t>
            </a:r>
            <a:r>
              <a:rPr lang="en-GB" b="0" dirty="0"/>
              <a:t> P, et al. Cardiac Resynchronization Therapy With Wireless Left Ventricular Endocardial Pacing: The SELECT-LV Study. </a:t>
            </a:r>
            <a:r>
              <a:rPr lang="en-GB" b="0" i="1" dirty="0"/>
              <a:t>J Am Coll </a:t>
            </a:r>
            <a:r>
              <a:rPr lang="en-GB" b="0" i="1" dirty="0" err="1"/>
              <a:t>Cardiol</a:t>
            </a:r>
            <a:r>
              <a:rPr lang="en-GB" b="0" dirty="0"/>
              <a:t>. 2017;69(17):2119-2129. doi:10.1016/j.jacc.2017.02.059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 err="1"/>
              <a:t>Teigeler</a:t>
            </a:r>
            <a:r>
              <a:rPr lang="en-GB" b="0" dirty="0"/>
              <a:t> T, </a:t>
            </a:r>
            <a:r>
              <a:rPr lang="en-GB" b="0" dirty="0" err="1"/>
              <a:t>Kolominsky</a:t>
            </a:r>
            <a:r>
              <a:rPr lang="en-GB" b="0" dirty="0"/>
              <a:t> J, Vo C, Shepard RK, </a:t>
            </a:r>
            <a:r>
              <a:rPr lang="en-GB" b="0" dirty="0" err="1"/>
              <a:t>Kalahasty</a:t>
            </a:r>
            <a:r>
              <a:rPr lang="en-GB" b="0" dirty="0"/>
              <a:t> G, Kron J, et al. Intermediate-term performance and safety of His-bundle pacing leads: A single-</a:t>
            </a:r>
            <a:r>
              <a:rPr lang="en-GB" b="0" dirty="0" err="1"/>
              <a:t>center</a:t>
            </a:r>
            <a:r>
              <a:rPr lang="en-GB" b="0" dirty="0"/>
              <a:t> experience. </a:t>
            </a:r>
            <a:r>
              <a:rPr lang="en-GB" b="0" i="1" dirty="0"/>
              <a:t>Heart Rhythm </a:t>
            </a:r>
            <a:r>
              <a:rPr lang="en-GB" b="0" dirty="0"/>
              <a:t>[Internet]. 2021;18(5):743–9. https://doi.org/10.1016/j.hrthm.2020.12.031</a:t>
            </a:r>
          </a:p>
          <a:p>
            <a:pPr marL="457200" indent="-457200">
              <a:buFont typeface="+mj-lt"/>
              <a:buAutoNum type="arabicPeriod"/>
            </a:pPr>
            <a:r>
              <a:rPr lang="en-GB" b="0" dirty="0"/>
              <a:t>Zhong C, Xu W, Shi S, Zhou X, Zhu Z. Left bundle branch pacing for cardiac resynchronization therapy: A systematic literature review and meta-analysis. </a:t>
            </a:r>
            <a:r>
              <a:rPr lang="en-GB" b="0" i="1" dirty="0"/>
              <a:t>Pacing Clin </a:t>
            </a:r>
            <a:r>
              <a:rPr lang="en-GB" b="0" i="1" dirty="0" err="1"/>
              <a:t>Electrophysiol</a:t>
            </a:r>
            <a:r>
              <a:rPr lang="en-GB" b="0" dirty="0"/>
              <a:t>. 2021 Mar;44(3):497-505. </a:t>
            </a:r>
            <a:r>
              <a:rPr lang="en-GB" b="0" dirty="0" err="1"/>
              <a:t>doi</a:t>
            </a:r>
            <a:r>
              <a:rPr lang="en-GB" b="0" dirty="0"/>
              <a:t>: 10.1111/pace.14174.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403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198783" y="1015770"/>
            <a:ext cx="5154989" cy="378235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Left bundle branch area pacing (LBBAP) can reverse left bundle branch block and deliver cardiac resynchronisation therapy (CRT).(1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 WiSE-CRT system delivers wireless endocardial pacing and can improve systems and LV remodelling in CRT non-responders.(2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n this series, we report the first case of deployment of the WiSE-CRT endocardial electrode into the left ventricular septum, demonstrating the technical feasibility of leadless LBBAP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  <a:p>
            <a:endParaRPr lang="en-GB" dirty="0"/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23D4EE9C-08FD-9C44-9A54-03801ED0C9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3562" y="892368"/>
            <a:ext cx="3031905" cy="323536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F6DEF04-24A9-A04A-B97B-16944C43FD92}"/>
              </a:ext>
            </a:extLst>
          </p:cNvPr>
          <p:cNvSpPr txBox="1"/>
          <p:nvPr/>
        </p:nvSpPr>
        <p:spPr>
          <a:xfrm>
            <a:off x="5353772" y="4201315"/>
            <a:ext cx="29314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1</a:t>
            </a:r>
            <a:r>
              <a:rPr lang="en-US" sz="1100" dirty="0"/>
              <a:t>. Components of the WiSE-CRT system.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– Case 1</a:t>
            </a:r>
            <a:br>
              <a:rPr lang="en-GB" sz="3200" b="0" dirty="0"/>
            </a:br>
            <a:r>
              <a:rPr lang="en-GB" sz="2200" b="0" dirty="0"/>
              <a:t>Previous history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403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276268" y="1349811"/>
            <a:ext cx="7943392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57 year old mal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schaemic cardiomyopathy (LV ejection fraction 32%), previous anterior myocardial infarction, and complete heart block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Underwent upgrade from dual chamber pacemaker to CRT-defibrillator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Difficult procedure, and LV lead threshold increased on routine monitoring with eventual loss of captur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Symptoms worsened with loss of CRT and patient underwent WiSE-CRT implantation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– Case 1</a:t>
            </a:r>
            <a:br>
              <a:rPr lang="en-GB" sz="3600" b="0" dirty="0"/>
            </a:br>
            <a:r>
              <a:rPr lang="en-GB" sz="2200" b="0" dirty="0"/>
              <a:t>WiSE-CRT Implant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23528" y="1230044"/>
            <a:ext cx="3784821" cy="3324146"/>
          </a:xfrm>
        </p:spPr>
        <p:txBody>
          <a:bodyPr>
            <a:normAutofit fontScale="925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WiSE-CRT system implanted via retrograde aortic approach and previously described technique (3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Prior to implantation of the LV electrode, different endocardial tested and acute haemodynamic response (AHR) and ECGs record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LBBAP achieved by pacing on the LV aspect of the septum where a left bundle potential was recorded</a:t>
            </a:r>
          </a:p>
        </p:txBody>
      </p:sp>
      <p:sp>
        <p:nvSpPr>
          <p:cNvPr id="14" name="Content Placeholder 4">
            <a:extLst>
              <a:ext uri="{FF2B5EF4-FFF2-40B4-BE49-F238E27FC236}">
                <a16:creationId xmlns:a16="http://schemas.microsoft.com/office/drawing/2014/main" id="{A11B92D0-97D6-A44C-8F25-AF3165A3B099}"/>
              </a:ext>
            </a:extLst>
          </p:cNvPr>
          <p:cNvSpPr txBox="1">
            <a:spLocks/>
          </p:cNvSpPr>
          <p:nvPr/>
        </p:nvSpPr>
        <p:spPr>
          <a:xfrm>
            <a:off x="4247964" y="1132221"/>
            <a:ext cx="4164516" cy="3421969"/>
          </a:xfrm>
          <a:prstGeom prst="rect">
            <a:avLst/>
          </a:prstGeom>
        </p:spPr>
        <p:txBody>
          <a:bodyPr vert="horz" lIns="0" tIns="0" rIns="0" bIns="0" rtlCol="0">
            <a:normAutofit fontScale="92500" lnSpcReduction="20000"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342900" indent="-342900">
              <a:lnSpc>
                <a:spcPct val="120000"/>
              </a:lnSpc>
              <a:buFont typeface="Arial" panose="020B0604020202020204" pitchFamily="34" charset="0"/>
              <a:buChar char="•"/>
            </a:pPr>
            <a:r>
              <a:rPr lang="en-GB" b="0" dirty="0"/>
              <a:t>The greatest AHR was achieved during LBBAP (34% increase from baseline RV-pacing) and was equivalent to biventricular pacing at the mid lateral LV wall</a:t>
            </a:r>
          </a:p>
          <a:p>
            <a:pPr marL="342900" indent="-342900">
              <a:lnSpc>
                <a:spcPct val="120000"/>
              </a:lnSpc>
              <a:buFont typeface="Arial" panose="020B0604020202020204" pitchFamily="34" charset="0"/>
              <a:buChar char="•"/>
            </a:pPr>
            <a:r>
              <a:rPr lang="en-GB" b="0" dirty="0"/>
              <a:t>Electrical resynchronization was superior during LBBAP (QRS 106ms) compared to biventricular pacing at the mid lateral LV wall (QRS 132ms) and baseline RV-pacing (QRS 172ms) as shown in figure 2.</a:t>
            </a:r>
          </a:p>
        </p:txBody>
      </p:sp>
      <p:sp>
        <p:nvSpPr>
          <p:cNvPr id="16" name="Footer Placeholder 2">
            <a:extLst>
              <a:ext uri="{FF2B5EF4-FFF2-40B4-BE49-F238E27FC236}">
                <a16:creationId xmlns:a16="http://schemas.microsoft.com/office/drawing/2014/main" id="{9040072F-7E60-F946-AB53-C4F95A0D1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71600" y="4796047"/>
            <a:ext cx="7200800" cy="274637"/>
          </a:xfrm>
        </p:spPr>
        <p:txBody>
          <a:bodyPr/>
          <a:lstStyle/>
          <a:p>
            <a:r>
              <a:rPr lang="en-GB" dirty="0"/>
              <a:t>EHJ-CR-D-21-00403 </a:t>
            </a: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– Case 1</a:t>
            </a:r>
            <a:br>
              <a:rPr lang="en-GB" sz="3200" b="0" dirty="0"/>
            </a:br>
            <a:r>
              <a:rPr lang="en-GB" sz="2200" b="0" dirty="0"/>
              <a:t>WiSE-CRT Implant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pic>
        <p:nvPicPr>
          <p:cNvPr id="9" name="Picture 8" descr="A close up of text on a whiteboard&#10;&#10;Description automatically generated">
            <a:extLst>
              <a:ext uri="{FF2B5EF4-FFF2-40B4-BE49-F238E27FC236}">
                <a16:creationId xmlns:a16="http://schemas.microsoft.com/office/drawing/2014/main" id="{AF0BE085-A6DE-8349-A35C-6DB358576D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7" r="5810" b="6289"/>
          <a:stretch/>
        </p:blipFill>
        <p:spPr>
          <a:xfrm>
            <a:off x="206955" y="1518698"/>
            <a:ext cx="2825808" cy="2075402"/>
          </a:xfrm>
          <a:prstGeom prst="rect">
            <a:avLst/>
          </a:prstGeom>
        </p:spPr>
      </p:pic>
      <p:pic>
        <p:nvPicPr>
          <p:cNvPr id="11" name="Picture 10" descr="A close up of text on a white surface&#10;&#10;Description automatically generated">
            <a:extLst>
              <a:ext uri="{FF2B5EF4-FFF2-40B4-BE49-F238E27FC236}">
                <a16:creationId xmlns:a16="http://schemas.microsoft.com/office/drawing/2014/main" id="{B4C56DEC-C862-2C40-BAF2-74322343E80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8" r="7449" b="3786"/>
          <a:stretch/>
        </p:blipFill>
        <p:spPr>
          <a:xfrm>
            <a:off x="3144946" y="1518147"/>
            <a:ext cx="2797509" cy="2075399"/>
          </a:xfrm>
          <a:prstGeom prst="rect">
            <a:avLst/>
          </a:prstGeom>
        </p:spPr>
      </p:pic>
      <p:pic>
        <p:nvPicPr>
          <p:cNvPr id="13" name="Picture 12" descr="A close up of a whiteboard&#10;&#10;Description automatically generated">
            <a:extLst>
              <a:ext uri="{FF2B5EF4-FFF2-40B4-BE49-F238E27FC236}">
                <a16:creationId xmlns:a16="http://schemas.microsoft.com/office/drawing/2014/main" id="{153D715B-14C0-444A-A487-AE005F61789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2" t="-1" r="7332" b="4483"/>
          <a:stretch/>
        </p:blipFill>
        <p:spPr>
          <a:xfrm>
            <a:off x="6054638" y="1518146"/>
            <a:ext cx="2825804" cy="207539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643C42F-8853-9142-B570-4D18071D5767}"/>
              </a:ext>
            </a:extLst>
          </p:cNvPr>
          <p:cNvSpPr txBox="1"/>
          <p:nvPr/>
        </p:nvSpPr>
        <p:spPr>
          <a:xfrm>
            <a:off x="2819400" y="1518146"/>
            <a:ext cx="213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7F5B62-58A6-D747-89E1-48CB9749DE0E}"/>
              </a:ext>
            </a:extLst>
          </p:cNvPr>
          <p:cNvSpPr txBox="1"/>
          <p:nvPr/>
        </p:nvSpPr>
        <p:spPr>
          <a:xfrm>
            <a:off x="5729092" y="1524992"/>
            <a:ext cx="213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8C8EB0A-39B6-8546-AE1B-5CE420A2E335}"/>
              </a:ext>
            </a:extLst>
          </p:cNvPr>
          <p:cNvSpPr txBox="1"/>
          <p:nvPr/>
        </p:nvSpPr>
        <p:spPr>
          <a:xfrm>
            <a:off x="8667079" y="1514752"/>
            <a:ext cx="213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AAA5688-A6A8-D243-86A4-CB15F3E3BCB7}"/>
              </a:ext>
            </a:extLst>
          </p:cNvPr>
          <p:cNvSpPr txBox="1"/>
          <p:nvPr/>
        </p:nvSpPr>
        <p:spPr>
          <a:xfrm>
            <a:off x="2303354" y="3378101"/>
            <a:ext cx="729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QRSd</a:t>
            </a:r>
            <a:r>
              <a:rPr lang="en-US" sz="800" dirty="0"/>
              <a:t> 172 </a:t>
            </a:r>
            <a:r>
              <a:rPr lang="en-US" sz="800" dirty="0" err="1"/>
              <a:t>ms</a:t>
            </a:r>
            <a:endParaRPr lang="en-US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294892-943C-AA48-97F3-F3C55E38DC92}"/>
              </a:ext>
            </a:extLst>
          </p:cNvPr>
          <p:cNvSpPr txBox="1"/>
          <p:nvPr/>
        </p:nvSpPr>
        <p:spPr>
          <a:xfrm>
            <a:off x="5209959" y="3384947"/>
            <a:ext cx="729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QRSd</a:t>
            </a:r>
            <a:r>
              <a:rPr lang="en-US" sz="800" dirty="0"/>
              <a:t> 132 </a:t>
            </a:r>
            <a:r>
              <a:rPr lang="en-US" sz="800" dirty="0" err="1"/>
              <a:t>ms</a:t>
            </a:r>
            <a:endParaRPr lang="en-US" sz="8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BF4354-0B6C-F143-A8B7-5317FF9BA1A3}"/>
              </a:ext>
            </a:extLst>
          </p:cNvPr>
          <p:cNvSpPr txBox="1"/>
          <p:nvPr/>
        </p:nvSpPr>
        <p:spPr>
          <a:xfrm>
            <a:off x="8137786" y="3378101"/>
            <a:ext cx="729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/>
              <a:t>QRSd</a:t>
            </a:r>
            <a:r>
              <a:rPr lang="en-US" sz="800" dirty="0"/>
              <a:t> 106 </a:t>
            </a:r>
            <a:r>
              <a:rPr lang="en-US" sz="800" dirty="0" err="1"/>
              <a:t>ms</a:t>
            </a:r>
            <a:endParaRPr lang="en-US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122A8D6-CED3-3940-8FC6-BA68955B84B5}"/>
              </a:ext>
            </a:extLst>
          </p:cNvPr>
          <p:cNvSpPr txBox="1"/>
          <p:nvPr/>
        </p:nvSpPr>
        <p:spPr>
          <a:xfrm>
            <a:off x="206955" y="3800723"/>
            <a:ext cx="86602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Figure 2.</a:t>
            </a:r>
            <a:r>
              <a:rPr lang="en-GB" sz="1400" dirty="0"/>
              <a:t>  A: Right ventricular pacing. B: Biventricular pacing with electrode at mid lateral wall of left ventricle. C: Biventricular pacing with electrode at left bundle branch area.  </a:t>
            </a:r>
            <a:r>
              <a:rPr lang="en-GB" sz="1400" dirty="0" err="1"/>
              <a:t>QRSd</a:t>
            </a:r>
            <a:r>
              <a:rPr lang="en-GB" sz="1400" dirty="0"/>
              <a:t>: QRS duration.</a:t>
            </a:r>
          </a:p>
          <a:p>
            <a:endParaRPr lang="en-US" sz="1400" dirty="0"/>
          </a:p>
        </p:txBody>
      </p:sp>
      <p:sp>
        <p:nvSpPr>
          <p:cNvPr id="21" name="Footer Placeholder 2">
            <a:extLst>
              <a:ext uri="{FF2B5EF4-FFF2-40B4-BE49-F238E27FC236}">
                <a16:creationId xmlns:a16="http://schemas.microsoft.com/office/drawing/2014/main" id="{BA36A657-BEF3-B548-BD92-9EDDDA755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GB" dirty="0"/>
              <a:t>EHJ-CR-D-21-00403 </a:t>
            </a:r>
          </a:p>
        </p:txBody>
      </p:sp>
    </p:spTree>
    <p:extLst>
      <p:ext uri="{BB962C8B-B14F-4D97-AF65-F5344CB8AC3E}">
        <p14:creationId xmlns:p14="http://schemas.microsoft.com/office/powerpoint/2010/main" val="3129271560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C340F3-2ABF-4F4F-94D6-BC5CAE12F680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45E6D424-E206-5D4B-8132-EFEEDF2E5CC9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421419" y="1160390"/>
            <a:ext cx="8086477" cy="3371854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52 year old mal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Tachyarrhythmia-induced cardiomyopathy (LV ejection fraction 30%) underwent upgrade from dual chamber pacemaker to CRT prior to atrioventricular node abl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Complex procedure due to persistent left-sided superior vena cava, requiring implantation of coronary sinus (CS) lead via the right subclavian vein and tunneling across to left-sided generator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4 years later patient required device replacement due to lead malfunction, but implantation of new CS lead not possible due to CS thrombosi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Patient therefore underwent WiSE-CRT implantation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4B7EA6EA-7A0B-E047-8F50-6B0903BB63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– Case 2</a:t>
            </a:r>
            <a:br>
              <a:rPr lang="en-GB" sz="3200" b="0" dirty="0"/>
            </a:br>
            <a:r>
              <a:rPr lang="en-GB" sz="2200" b="0" dirty="0"/>
              <a:t>Previous history</a:t>
            </a:r>
          </a:p>
        </p:txBody>
      </p:sp>
      <p:sp>
        <p:nvSpPr>
          <p:cNvPr id="13" name="Footer Placeholder 2">
            <a:extLst>
              <a:ext uri="{FF2B5EF4-FFF2-40B4-BE49-F238E27FC236}">
                <a16:creationId xmlns:a16="http://schemas.microsoft.com/office/drawing/2014/main" id="{C7B4B7DB-1EAE-9E48-8985-6B77EA7E1332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GB" dirty="0"/>
              <a:t>EHJ-CR-D-21-00403</a:t>
            </a:r>
          </a:p>
        </p:txBody>
      </p:sp>
    </p:spTree>
    <p:extLst>
      <p:ext uri="{BB962C8B-B14F-4D97-AF65-F5344CB8AC3E}">
        <p14:creationId xmlns:p14="http://schemas.microsoft.com/office/powerpoint/2010/main" val="53277331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FCF83C-78AC-3C4A-B1CB-7E7FDCB29CE6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EHJ-CR-D-21-00403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45D42A-8582-754C-A48D-361567414174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C65A29C4-7371-3148-954E-5D834FB23EFD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341215" y="1635998"/>
            <a:ext cx="3173707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900" b="0" dirty="0"/>
              <a:t>Endocardial electrode implanted via a trans-septal intra-atrial approach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900" b="0" dirty="0"/>
              <a:t>Electrode implanted into the LV septum with improved electrical </a:t>
            </a:r>
            <a:r>
              <a:rPr lang="en-US" sz="1900" b="0" dirty="0" err="1"/>
              <a:t>resynchronisation</a:t>
            </a:r>
            <a:r>
              <a:rPr lang="en-US" sz="1900" b="0" dirty="0"/>
              <a:t> (figure 3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900" dirty="0"/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11E16886-913F-8B4C-85C8-01BF1E48C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 – Case 2</a:t>
            </a:r>
            <a:br>
              <a:rPr lang="en-GB" sz="3200" b="0" dirty="0"/>
            </a:br>
            <a:r>
              <a:rPr lang="en-GB" sz="2200" b="0" dirty="0"/>
              <a:t>WiSE-CRT Implantation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F694F23-036F-1A40-9CDA-9E59ED2E3B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575" y="951613"/>
            <a:ext cx="4347823" cy="2894556"/>
          </a:xfrm>
          <a:prstGeom prst="rect">
            <a:avLst/>
          </a:prstGeom>
        </p:spPr>
      </p:pic>
      <p:sp>
        <p:nvSpPr>
          <p:cNvPr id="11" name="Content Placeholder 4">
            <a:extLst>
              <a:ext uri="{FF2B5EF4-FFF2-40B4-BE49-F238E27FC236}">
                <a16:creationId xmlns:a16="http://schemas.microsoft.com/office/drawing/2014/main" id="{72B033E1-8955-C249-9A18-05C3317B33C9}"/>
              </a:ext>
            </a:extLst>
          </p:cNvPr>
          <p:cNvSpPr txBox="1">
            <a:spLocks/>
          </p:cNvSpPr>
          <p:nvPr/>
        </p:nvSpPr>
        <p:spPr>
          <a:xfrm>
            <a:off x="3832526" y="3885765"/>
            <a:ext cx="4347823" cy="500930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Figure 3</a:t>
            </a:r>
            <a:r>
              <a:rPr lang="en-GB" sz="1000" dirty="0"/>
              <a:t>. </a:t>
            </a:r>
            <a:r>
              <a:rPr lang="en-GB" sz="1000" b="0" dirty="0"/>
              <a:t>Electrode and lead positions on (A) chest X-ray prior to WiSE-CRT implant and (B) intra-procedure fluoroscopy after WiSE-CRT implant. Surface ECGs during right ventricular pacing (C) and biventricular pacing with the endocardial electrode in the left ventricular septum (D)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88880425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403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2" y="1063625"/>
            <a:ext cx="3792330" cy="3493503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Conventional and endocardial CRT deliver two non-physiological waves to resynchronise the myocardium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Conduction system pacing can recruit the intrinsic His-Purkinje system to reverse left bundle branch block (LBBB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His bundle pacing is feasible in delivering CRT but is limited by high pacing thresholds (4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500438" y="985961"/>
            <a:ext cx="3792330" cy="3406039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LBBAP can reverse LBBB at lower thresholds (5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t is usually performed by an RV approach using delivery tools designed for His bundle pacing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n this case, we demonstrate the feasibility of a left ventricular approach and report the first case of leadless LBBAP delivered via the WiSE-CRT system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EHJ-CR-D-21-00403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68600" y="1840963"/>
            <a:ext cx="2206800" cy="2266005"/>
          </a:xfrm>
        </p:spPr>
        <p:txBody>
          <a:bodyPr>
            <a:normAutofit/>
          </a:bodyPr>
          <a:lstStyle/>
          <a:p>
            <a:pPr lvl="0"/>
            <a:r>
              <a:rPr lang="en-GB" b="0" dirty="0"/>
              <a:t>Deployment of the WiSE-CRT endocardial electrode in the LV septum is feasible</a:t>
            </a:r>
          </a:p>
          <a:p>
            <a:endParaRPr lang="en-GB" sz="2400" b="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39552" y="1840963"/>
            <a:ext cx="2651286" cy="3116394"/>
          </a:xfrm>
        </p:spPr>
        <p:txBody>
          <a:bodyPr>
            <a:normAutofit/>
          </a:bodyPr>
          <a:lstStyle/>
          <a:p>
            <a:pPr lvl="0"/>
            <a:r>
              <a:rPr lang="en-GB" b="0" dirty="0"/>
              <a:t>LBBAP from the LV aspect of the septum achieves excellent electrical resynchronisation and haemodynamic response</a:t>
            </a:r>
          </a:p>
          <a:p>
            <a:endParaRPr lang="en-GB" sz="2400" b="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F1D063D-EE3F-3846-85FD-012EAE290425}"/>
              </a:ext>
            </a:extLst>
          </p:cNvPr>
          <p:cNvSpPr txBox="1"/>
          <p:nvPr/>
        </p:nvSpPr>
        <p:spPr>
          <a:xfrm>
            <a:off x="5850457" y="1910030"/>
            <a:ext cx="248752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sz="2000" dirty="0"/>
              <a:t>This demonstrates the technical feasibility of leadless LBBAP using the WiSE-CRT system</a:t>
            </a: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</TotalTime>
  <Words>931</Words>
  <Application>Microsoft Macintosh PowerPoint</Application>
  <PresentationFormat>On-screen Show (16:9)</PresentationFormat>
  <Paragraphs>74</Paragraphs>
  <Slides>1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Technical feasibility of leadless left bundle branch area pacing for cardiac resynchronisation: a case series</vt:lpstr>
      <vt:lpstr>Introduction</vt:lpstr>
      <vt:lpstr>Case Presentation – Case 1 Previous history</vt:lpstr>
      <vt:lpstr>Case Presentation – Case 1 WiSE-CRT Implantation</vt:lpstr>
      <vt:lpstr>Case Presentation – Case 1 WiSE-CRT Implantation</vt:lpstr>
      <vt:lpstr>Case Presentation – Case 2 Previous history</vt:lpstr>
      <vt:lpstr>Case Presentation – Case 2 WiSE-CRT Implantation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Elliott, Mark</cp:lastModifiedBy>
  <cp:revision>65</cp:revision>
  <dcterms:created xsi:type="dcterms:W3CDTF">2017-10-02T09:19:02Z</dcterms:created>
  <dcterms:modified xsi:type="dcterms:W3CDTF">2021-07-06T09:12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